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5" r:id="rId3"/>
    <p:sldId id="264" r:id="rId4"/>
    <p:sldId id="256" r:id="rId5"/>
    <p:sldId id="257" r:id="rId6"/>
    <p:sldId id="263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7" autoAdjust="0"/>
    <p:restoredTop sz="94660"/>
  </p:normalViewPr>
  <p:slideViewPr>
    <p:cSldViewPr snapToGrid="0">
      <p:cViewPr varScale="1">
        <p:scale>
          <a:sx n="45" d="100"/>
          <a:sy n="45" d="100"/>
        </p:scale>
        <p:origin x="72" y="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0896C42-E7F3-5CDD-C694-20F980F9C9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03B4DDA5-F10B-8403-1C1A-3DDF21EDCD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9013BE1-DBF9-8D83-2978-31019CD7C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7F17D92-1189-5788-2DA9-A71691715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FACA9DE-D625-64C7-4F0C-66AF0486A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9334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C75CB7C-F191-158C-DE2D-41E99819FC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F36B547A-DEAF-9BDF-C401-EE0BE8A08C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004877CB-0C47-12A4-1F64-85E19E873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D28E1BD-CFFE-13AF-2E41-5EE8A13A6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30574D40-751E-3A4D-98BC-080005546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473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AC66E85D-BFBE-746C-1E17-51AB7E61C0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375B5EBF-A81D-0053-C5E9-EE7BE39D47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EA63032-6263-3208-A72D-6C8EC82C9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57C6DC6-E43F-7C5B-135F-9356C97DE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B7A9C606-407A-CBCB-0800-CFF7A4B47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023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A895340-C689-3E70-B23C-1190B5FD00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C28DCFFC-2281-1199-68FC-0CD75CE8B5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54C0D02-A6D9-9559-6129-26F5F0553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9B656131-2089-FFCE-9B5A-3113E9ABC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B67E91A-8624-C520-6844-26ECA18B4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894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1EC4672-411F-5254-21A6-7CEEE0629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5ED85D5A-35A2-02AC-6929-8F08E58A3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C28F591-1B06-F49F-DB4C-DF03B3814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D7FCABA-8DE8-6003-AC87-3B0B1FD62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83803090-2FC0-348C-648B-5015CF658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162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12E2767-11F2-4500-2CE2-D0A09EA521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FC19E736-6CAE-0D66-B56E-9BCC747CE9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7DB4167B-FA85-D731-A661-3E8C29626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8EFCB757-DC30-0337-D07B-096332D11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7E66D261-E320-22F3-0FAB-140B38B7A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4CC97DB2-EDFD-2EA9-9D3D-DF7A82FE7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7577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341349A-3692-9A8E-6240-0E1A55A32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C3C622DE-45EA-1D64-6DEC-47600D699C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2FF4887D-AB4D-7452-91F6-90C179E23C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3AC6414B-9EB1-6499-4BF3-F86ACD590F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76571B2A-5AEC-980B-FD78-9F868BD1CB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10CA7BDA-AAFE-F5B6-1365-DCD0B5EAD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FFA9232C-5484-ECF5-92CD-64C71E3DD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68CCC57E-2AC8-B5BD-AF1B-950FE0906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0677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A5D8AED-2D81-06CB-C6DF-24FA2DC53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83370500-CF7D-BB6A-AF1B-2679DD55F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E52BA4A8-41BD-9534-6CC9-D138902A5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9FFB9B60-52B1-B009-6203-DFD092DA8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3970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1863E1A3-1C76-46D2-47C8-FDC75F1E1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D8FFB134-A989-8ECF-FBF4-55697E348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F450424F-0C81-4C60-4160-61AB389C4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352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BB6B8A2-ECD4-7D18-EF84-484C06627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AD3C34D5-0EFC-BB1F-520A-85B4664CE6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00BA542D-7188-A770-176E-385D1CE9F6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DA1E6A8-04BF-9AAA-2CDC-0F4D349FE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D79B0A81-29A3-9E33-5270-783BA70F7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56C9B0FA-6C64-D038-0C63-CD90C45AF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675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F6CA967-5D23-49BE-654D-8E917B048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7779E2A5-E722-4111-4265-DFB6756EF7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95AE97CE-E129-7C47-459B-D13C2A6432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848DD049-F432-D0BE-2F46-5D7BD7933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B7CB713B-FE87-914A-6011-C172403A3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C4C8E59E-66A4-48A7-2B08-DD90FB815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0919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A09DB1B7-706C-DF70-BBF1-BF2D2D0490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762B1C8-62B8-9165-FDCE-D864B3A1A7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917F1BE4-5200-F6DB-950C-0661E653A0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9C3A8-1E36-4B4E-B7C4-63FB90843A4A}" type="datetimeFigureOut">
              <a:rPr kumimoji="1" lang="ja-JP" altLang="en-US" smtClean="0"/>
              <a:t>2023/3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E34F85C-8AF7-E454-9B35-53DDCE677C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84E77401-CF16-C225-C698-1E6180E272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BA38B-F8F9-4DCD-8C4A-90B59FF925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829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75C73C7E-2BE3-2A8C-AA01-16E6A5040C1D}"/>
              </a:ext>
            </a:extLst>
          </p:cNvPr>
          <p:cNvSpPr txBox="1"/>
          <p:nvPr/>
        </p:nvSpPr>
        <p:spPr>
          <a:xfrm>
            <a:off x="243886" y="172797"/>
            <a:ext cx="58521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of Fig. 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4 lanes shown as 4-week were used in Figure 6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xmlns="" id="{1C2C779E-FFBD-7BE5-6BFA-F7B895E2643D}"/>
              </a:ext>
            </a:extLst>
          </p:cNvPr>
          <p:cNvGrpSpPr/>
          <p:nvPr/>
        </p:nvGrpSpPr>
        <p:grpSpPr>
          <a:xfrm>
            <a:off x="1864646" y="1078186"/>
            <a:ext cx="5050519" cy="5447348"/>
            <a:chOff x="1141310" y="900762"/>
            <a:chExt cx="5050519" cy="5447348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xmlns="" id="{CC009F93-28E6-E106-0B9E-25BE3B6581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9425" y="900762"/>
              <a:ext cx="4752404" cy="5447348"/>
            </a:xfrm>
            <a:prstGeom prst="rect">
              <a:avLst/>
            </a:prstGeom>
          </p:spPr>
        </p:pic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B133C276-DFE3-152F-9C91-43F9DAD8C969}"/>
                </a:ext>
              </a:extLst>
            </p:cNvPr>
            <p:cNvSpPr txBox="1"/>
            <p:nvPr/>
          </p:nvSpPr>
          <p:spPr>
            <a:xfrm flipH="1">
              <a:off x="4152925" y="1071302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-67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xmlns="" id="{B16A4CD2-FA43-73B7-AE0A-1B3977900BDD}"/>
                </a:ext>
              </a:extLst>
            </p:cNvPr>
            <p:cNvGrpSpPr/>
            <p:nvPr/>
          </p:nvGrpSpPr>
          <p:grpSpPr>
            <a:xfrm>
              <a:off x="3789766" y="4261657"/>
              <a:ext cx="1341168" cy="1286373"/>
              <a:chOff x="3557836" y="4291115"/>
              <a:chExt cx="1341168" cy="1254042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xmlns="" id="{2A28D399-CFF7-4415-61A1-11EA8214255D}"/>
                  </a:ext>
                </a:extLst>
              </p:cNvPr>
              <p:cNvGrpSpPr/>
              <p:nvPr/>
            </p:nvGrpSpPr>
            <p:grpSpPr>
              <a:xfrm>
                <a:off x="3557836" y="4291115"/>
                <a:ext cx="1341168" cy="1254042"/>
                <a:chOff x="8001775" y="1698750"/>
                <a:chExt cx="1779092" cy="1810483"/>
              </a:xfrm>
            </p:grpSpPr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xmlns="" id="{5F809DBB-2FE5-E1E2-5FA6-9404CEB88B44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660927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xmlns="" id="{F0073B92-A3B7-FF4B-EA5E-14E5CB1F3A70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94356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xmlns="" id="{E33C5A10-B4A2-7237-F59F-FD0B3270B0EF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51518" y="2637382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xmlns="" id="{0E554069-35EA-6B41-A50D-547B6D8BE00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" name="直線コネクタ 9">
                  <a:extLst>
                    <a:ext uri="{FF2B5EF4-FFF2-40B4-BE49-F238E27FC236}">
                      <a16:creationId xmlns:a16="http://schemas.microsoft.com/office/drawing/2014/main" xmlns="" id="{091246EF-6A90-3FA9-9808-6338777E7A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13937" y="1980130"/>
                  <a:ext cx="176693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xmlns="" id="{9EE31766-05C2-8D2F-632A-0745FA2C0D0D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13F9C770-03C9-3F71-811D-ED11047E9D4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79959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xmlns="" id="{BCE19582-551C-853F-95BA-C4187FA9484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21838" y="4577757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xmlns="" id="{158FE997-586F-BCDA-BB07-19B4C454771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xmlns="" id="{4C75BD8C-8101-98BE-0CE6-5381AAE504F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6703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xmlns="" id="{27899BB5-9F25-E7DC-785F-910A30EA79E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2311" y="4583899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xmlns="" id="{35DC52C1-5A5F-23D7-CF51-C9170D360169}"/>
                </a:ext>
              </a:extLst>
            </p:cNvPr>
            <p:cNvGrpSpPr/>
            <p:nvPr/>
          </p:nvGrpSpPr>
          <p:grpSpPr>
            <a:xfrm>
              <a:off x="1141310" y="2207619"/>
              <a:ext cx="228415" cy="1995161"/>
              <a:chOff x="1854413" y="1978007"/>
              <a:chExt cx="228415" cy="1995161"/>
            </a:xfrm>
          </p:grpSpPr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xmlns="" id="{250FB1A7-D7FF-8EC6-A8B2-E9558E4B8193}"/>
                  </a:ext>
                </a:extLst>
              </p:cNvPr>
              <p:cNvGrpSpPr/>
              <p:nvPr/>
            </p:nvGrpSpPr>
            <p:grpSpPr>
              <a:xfrm>
                <a:off x="1854413" y="1978007"/>
                <a:ext cx="228415" cy="1995161"/>
                <a:chOff x="387641" y="1672351"/>
                <a:chExt cx="228415" cy="1995161"/>
              </a:xfrm>
            </p:grpSpPr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xmlns="" id="{8168FCDA-0283-962B-C8C9-98B5DB0B20B0}"/>
                    </a:ext>
                  </a:extLst>
                </p:cNvPr>
                <p:cNvSpPr txBox="1"/>
                <p:nvPr/>
              </p:nvSpPr>
              <p:spPr>
                <a:xfrm>
                  <a:off x="387641" y="2384721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150</a:t>
                  </a:r>
                  <a:endParaRPr lang="ja-JP" altLang="en-US" sz="1000" dirty="0"/>
                </a:p>
              </p:txBody>
            </p:sp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xmlns="" id="{8D3CA6F4-9DC8-4AE7-5084-15789D65FEDF}"/>
                    </a:ext>
                  </a:extLst>
                </p:cNvPr>
                <p:cNvSpPr txBox="1"/>
                <p:nvPr/>
              </p:nvSpPr>
              <p:spPr>
                <a:xfrm>
                  <a:off x="402372" y="2137571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200</a:t>
                  </a:r>
                  <a:endParaRPr lang="ja-JP" altLang="en-US" sz="1000" dirty="0"/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xmlns="" id="{53FBBC28-3DEA-3965-5047-209B1486A0DD}"/>
                    </a:ext>
                  </a:extLst>
                </p:cNvPr>
                <p:cNvSpPr txBox="1"/>
                <p:nvPr/>
              </p:nvSpPr>
              <p:spPr>
                <a:xfrm>
                  <a:off x="434058" y="3513624"/>
                  <a:ext cx="141064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>
                      <a:solidFill>
                        <a:schemeClr val="tx1"/>
                      </a:solidFill>
                    </a:rPr>
                    <a:t>50</a:t>
                  </a:r>
                  <a:endParaRPr lang="ja-JP" altLang="en-US" sz="10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xmlns="" id="{797C6ABB-B717-39A6-B943-8FD7DEE307A2}"/>
                    </a:ext>
                  </a:extLst>
                </p:cNvPr>
                <p:cNvSpPr txBox="1"/>
                <p:nvPr/>
              </p:nvSpPr>
              <p:spPr>
                <a:xfrm>
                  <a:off x="387641" y="2814107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/>
                    <a:t>100</a:t>
                  </a:r>
                  <a:endParaRPr lang="ja-JP" altLang="en-US" sz="1000" dirty="0"/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xmlns="" id="{99AFF0C4-015D-37AD-AE9E-2DC63E4324C4}"/>
                    </a:ext>
                  </a:extLst>
                </p:cNvPr>
                <p:cNvSpPr txBox="1"/>
                <p:nvPr/>
              </p:nvSpPr>
              <p:spPr>
                <a:xfrm flipH="1">
                  <a:off x="393124" y="1672351"/>
                  <a:ext cx="2229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bp</a:t>
                  </a:r>
                  <a:endParaRPr lang="ja-JP" altLang="en-US" sz="1000" dirty="0"/>
                </a:p>
              </p:txBody>
            </p:sp>
          </p:grp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xmlns="" id="{606AB6BF-C153-3A12-CAB6-79E098575691}"/>
                  </a:ext>
                </a:extLst>
              </p:cNvPr>
              <p:cNvSpPr txBox="1"/>
              <p:nvPr/>
            </p:nvSpPr>
            <p:spPr>
              <a:xfrm>
                <a:off x="1871208" y="2289339"/>
                <a:ext cx="21159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250</a:t>
                </a:r>
                <a:endParaRPr lang="ja-JP" altLang="en-US" sz="10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25492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92828512-FDBB-698E-A69E-2C2C0D50F1ED}"/>
              </a:ext>
            </a:extLst>
          </p:cNvPr>
          <p:cNvSpPr txBox="1"/>
          <p:nvPr/>
        </p:nvSpPr>
        <p:spPr>
          <a:xfrm>
            <a:off x="243893" y="172797"/>
            <a:ext cx="55659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of Fig. 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4 lanes shown as 4-week were used in Figure 6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xmlns="" id="{5C440F70-0456-679D-73DA-D37DB4790C3F}"/>
              </a:ext>
            </a:extLst>
          </p:cNvPr>
          <p:cNvGrpSpPr/>
          <p:nvPr/>
        </p:nvGrpSpPr>
        <p:grpSpPr>
          <a:xfrm>
            <a:off x="1905851" y="876795"/>
            <a:ext cx="9620211" cy="5263039"/>
            <a:chOff x="1905851" y="985979"/>
            <a:chExt cx="9620211" cy="526303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xmlns="" id="{7951175E-98CC-9E54-633F-1A782FB212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49188" y="985979"/>
              <a:ext cx="9276874" cy="5263039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5A9C7FBF-9794-2EA5-2B5F-9EC2C5C5EF68}"/>
                </a:ext>
              </a:extLst>
            </p:cNvPr>
            <p:cNvSpPr txBox="1"/>
            <p:nvPr/>
          </p:nvSpPr>
          <p:spPr>
            <a:xfrm flipH="1">
              <a:off x="4944182" y="1205565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1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xmlns="" id="{139AA282-1E39-486A-7C54-CB170AC490B1}"/>
                </a:ext>
              </a:extLst>
            </p:cNvPr>
            <p:cNvSpPr txBox="1"/>
            <p:nvPr/>
          </p:nvSpPr>
          <p:spPr>
            <a:xfrm flipH="1">
              <a:off x="9065458" y="1197149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M7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xmlns="" id="{432FBF3B-E3F8-5D04-D990-55C5F1EE8E55}"/>
                </a:ext>
              </a:extLst>
            </p:cNvPr>
            <p:cNvGrpSpPr/>
            <p:nvPr/>
          </p:nvGrpSpPr>
          <p:grpSpPr>
            <a:xfrm>
              <a:off x="1905851" y="1722789"/>
              <a:ext cx="228980" cy="2020433"/>
              <a:chOff x="882483" y="1839263"/>
              <a:chExt cx="228980" cy="2020433"/>
            </a:xfrm>
          </p:grpSpPr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xmlns="" id="{E2A42F8D-BD2A-6592-AC47-B8F765AA10E2}"/>
                  </a:ext>
                </a:extLst>
              </p:cNvPr>
              <p:cNvGrpSpPr/>
              <p:nvPr/>
            </p:nvGrpSpPr>
            <p:grpSpPr>
              <a:xfrm>
                <a:off x="882483" y="2696754"/>
                <a:ext cx="212018" cy="1162942"/>
                <a:chOff x="6994114" y="4611518"/>
                <a:chExt cx="212018" cy="1162942"/>
              </a:xfrm>
            </p:grpSpPr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xmlns="" id="{5674D55C-2743-DCFD-8653-40A8F345ACE1}"/>
                    </a:ext>
                  </a:extLst>
                </p:cNvPr>
                <p:cNvSpPr txBox="1"/>
                <p:nvPr/>
              </p:nvSpPr>
              <p:spPr>
                <a:xfrm>
                  <a:off x="7064646" y="5620572"/>
                  <a:ext cx="141064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>
                      <a:solidFill>
                        <a:schemeClr val="tx1"/>
                      </a:solidFill>
                    </a:rPr>
                    <a:t>50</a:t>
                  </a:r>
                  <a:endParaRPr lang="ja-JP" altLang="en-US" sz="10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xmlns="" id="{DAB9D0F0-0E7E-8E8F-5774-FC1A9BC8709A}"/>
                    </a:ext>
                  </a:extLst>
                </p:cNvPr>
                <p:cNvSpPr txBox="1"/>
                <p:nvPr/>
              </p:nvSpPr>
              <p:spPr>
                <a:xfrm>
                  <a:off x="6994536" y="5144289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/>
                    <a:t>100</a:t>
                  </a:r>
                  <a:endParaRPr lang="ja-JP" altLang="en-US" sz="1000" dirty="0"/>
                </a:p>
              </p:txBody>
            </p: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xmlns="" id="{E37D7132-8F0B-C325-C7B8-6ED93A210328}"/>
                    </a:ext>
                  </a:extLst>
                </p:cNvPr>
                <p:cNvSpPr txBox="1"/>
                <p:nvPr/>
              </p:nvSpPr>
              <p:spPr>
                <a:xfrm>
                  <a:off x="6994114" y="4825422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150</a:t>
                  </a:r>
                  <a:endParaRPr lang="ja-JP" altLang="en-US" sz="1000" dirty="0"/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xmlns="" id="{CC47A6E7-CE78-8AAD-092E-B17CA41B8712}"/>
                    </a:ext>
                  </a:extLst>
                </p:cNvPr>
                <p:cNvSpPr txBox="1"/>
                <p:nvPr/>
              </p:nvSpPr>
              <p:spPr>
                <a:xfrm>
                  <a:off x="6994114" y="4611518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200</a:t>
                  </a:r>
                  <a:endParaRPr lang="ja-JP" altLang="en-US" sz="1000" dirty="0"/>
                </a:p>
              </p:txBody>
            </p:sp>
          </p:grp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xmlns="" id="{B01F8700-37A2-2DF6-9352-2666999D7437}"/>
                  </a:ext>
                </a:extLst>
              </p:cNvPr>
              <p:cNvSpPr txBox="1"/>
              <p:nvPr/>
            </p:nvSpPr>
            <p:spPr>
              <a:xfrm flipH="1">
                <a:off x="888531" y="1839263"/>
                <a:ext cx="22293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bp</a:t>
                </a:r>
                <a:endParaRPr lang="ja-JP" altLang="en-US" sz="1000" dirty="0"/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xmlns="" id="{ECBF9E7A-9CBB-199B-1D82-19813CA384C0}"/>
                </a:ext>
              </a:extLst>
            </p:cNvPr>
            <p:cNvGrpSpPr/>
            <p:nvPr/>
          </p:nvGrpSpPr>
          <p:grpSpPr>
            <a:xfrm>
              <a:off x="4633134" y="4709793"/>
              <a:ext cx="1419251" cy="1286373"/>
              <a:chOff x="3507726" y="4291115"/>
              <a:chExt cx="1419251" cy="1254042"/>
            </a:xfrm>
          </p:grpSpPr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xmlns="" id="{F18F01CC-276D-27B6-3B25-3ABD191B7E2E}"/>
                  </a:ext>
                </a:extLst>
              </p:cNvPr>
              <p:cNvGrpSpPr/>
              <p:nvPr/>
            </p:nvGrpSpPr>
            <p:grpSpPr>
              <a:xfrm>
                <a:off x="3507726" y="4291115"/>
                <a:ext cx="1419251" cy="1254042"/>
                <a:chOff x="7935301" y="1698750"/>
                <a:chExt cx="1882672" cy="1810483"/>
              </a:xfrm>
            </p:grpSpPr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xmlns="" id="{91A03F7B-3ED5-0F2D-FF27-9EE03B124AC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594453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xmlns="" id="{8DD80F1A-3367-1A99-D4DC-65CEA650B4B4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27884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xmlns="" id="{828805D8-CB2C-0DD8-560A-BEB67139F1B6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01663" y="2637382"/>
                  <a:ext cx="1036948" cy="300579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xmlns="" id="{2E018353-D211-471A-5E9C-662BB751F8C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xmlns="" id="{4A5FC116-D230-3EE9-A17A-F61DDF3B7B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55533" y="1980422"/>
                  <a:ext cx="186244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xmlns="" id="{D53F44BC-B2A3-6AF9-8B82-17C8A11F6637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xmlns="" id="{EA51B021-07FA-6791-0D58-D6D157D32D2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42375" y="458054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xmlns="" id="{C6EB74B4-EEBA-A3F2-978F-E2F31FBD595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768594" y="4577758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BB798F9C-E366-2324-CAF6-FB949D83B41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xmlns="" id="{0466ED86-E35B-3D98-1347-66B8E514721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8269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xmlns="" id="{D8DECDAA-CDD9-ED49-5AB1-36B64290AC1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24235" y="4583900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xmlns="" id="{FCCBEE48-AEAC-BE10-0411-0E2C60C04AF7}"/>
                </a:ext>
              </a:extLst>
            </p:cNvPr>
            <p:cNvGrpSpPr/>
            <p:nvPr/>
          </p:nvGrpSpPr>
          <p:grpSpPr>
            <a:xfrm>
              <a:off x="8815052" y="4694213"/>
              <a:ext cx="1341168" cy="1286373"/>
              <a:chOff x="3557836" y="4291115"/>
              <a:chExt cx="1341168" cy="1254042"/>
            </a:xfrm>
          </p:grpSpPr>
          <p:grpSp>
            <p:nvGrpSpPr>
              <p:cNvPr id="31" name="グループ化 30">
                <a:extLst>
                  <a:ext uri="{FF2B5EF4-FFF2-40B4-BE49-F238E27FC236}">
                    <a16:creationId xmlns:a16="http://schemas.microsoft.com/office/drawing/2014/main" xmlns="" id="{DA870EFC-0FFB-0D77-27F9-F9549B225A06}"/>
                  </a:ext>
                </a:extLst>
              </p:cNvPr>
              <p:cNvGrpSpPr/>
              <p:nvPr/>
            </p:nvGrpSpPr>
            <p:grpSpPr>
              <a:xfrm>
                <a:off x="3557836" y="4291115"/>
                <a:ext cx="1341168" cy="1254042"/>
                <a:chOff x="8001775" y="1698750"/>
                <a:chExt cx="1779092" cy="1810483"/>
              </a:xfrm>
            </p:grpSpPr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xmlns="" id="{30F17551-DF0F-3DEA-92FB-129D5484769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660927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xmlns="" id="{EDAA883E-A6ED-00BE-1F49-F59A7C03464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94356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xmlns="" id="{C196EE1F-4D8C-1F2F-F7AC-4ADE23CDC48E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51518" y="2637382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xmlns="" id="{1EE84E5C-4862-5F85-FBFC-21446E3A99F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xmlns="" id="{56691580-11F1-CBFB-8E7E-B3835BC712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13937" y="1980130"/>
                  <a:ext cx="176693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xmlns="" id="{E39A66BD-7357-AC6C-CA07-7E6733C441F0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xmlns="" id="{360BD426-6745-E4D2-BE8B-7FC8A423BA4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79959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xmlns="" id="{D3C7D5F4-4540-10CE-3ADE-A8B9B2A15AB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21838" y="4577757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xmlns="" id="{DE319A40-EA40-3E76-810C-662EC38052A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xmlns="" id="{CE462B6A-8FF0-F982-8B09-E14DE6310A6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6703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xmlns="" id="{1DFB82A6-63E5-EEAB-B9B1-AC3C2686CCD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2311" y="4583899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58F8AF84-B6C0-09F1-2F7D-84B91E551E0C}"/>
              </a:ext>
            </a:extLst>
          </p:cNvPr>
          <p:cNvSpPr txBox="1"/>
          <p:nvPr/>
        </p:nvSpPr>
        <p:spPr>
          <a:xfrm>
            <a:off x="5332107" y="6331421"/>
            <a:ext cx="640271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Although double bands of MCM7 were observed in the 0.1% HeLa and HeLa alone groups,</a:t>
            </a:r>
          </a:p>
          <a:p>
            <a:r>
              <a:rPr lang="en-US" altLang="ja-JP" sz="1100" dirty="0"/>
              <a:t>there is no effect on the conclusion because this marker is not useful to assess a tumorigenicity.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7404351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92828512-FDBB-698E-A69E-2C2C0D50F1ED}"/>
              </a:ext>
            </a:extLst>
          </p:cNvPr>
          <p:cNvSpPr txBox="1"/>
          <p:nvPr/>
        </p:nvSpPr>
        <p:spPr>
          <a:xfrm>
            <a:off x="243893" y="172797"/>
            <a:ext cx="55659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of Fig. 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4 lanes shown as 4-week were used in Figure 6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xmlns="" id="{09F3100C-49F0-7B67-FB57-45FE4170E67C}"/>
              </a:ext>
            </a:extLst>
          </p:cNvPr>
          <p:cNvGrpSpPr/>
          <p:nvPr/>
        </p:nvGrpSpPr>
        <p:grpSpPr>
          <a:xfrm>
            <a:off x="1837611" y="971659"/>
            <a:ext cx="9802652" cy="5501354"/>
            <a:chOff x="1892203" y="780590"/>
            <a:chExt cx="9802652" cy="5501354"/>
          </a:xfrm>
        </p:grpSpPr>
        <p:pic>
          <p:nvPicPr>
            <p:cNvPr id="44" name="図 43">
              <a:extLst>
                <a:ext uri="{FF2B5EF4-FFF2-40B4-BE49-F238E27FC236}">
                  <a16:creationId xmlns:a16="http://schemas.microsoft.com/office/drawing/2014/main" xmlns="" id="{A4F58647-A0D2-E58D-A2D6-60E9D3F4E14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89953" y="780590"/>
              <a:ext cx="9504902" cy="5501354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5A9C7FBF-9794-2EA5-2B5F-9EC2C5C5EF68}"/>
                </a:ext>
              </a:extLst>
            </p:cNvPr>
            <p:cNvSpPr txBox="1"/>
            <p:nvPr/>
          </p:nvSpPr>
          <p:spPr>
            <a:xfrm flipH="1">
              <a:off x="4998774" y="1014496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clin B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xmlns="" id="{139AA282-1E39-486A-7C54-CB170AC490B1}"/>
                </a:ext>
              </a:extLst>
            </p:cNvPr>
            <p:cNvSpPr txBox="1"/>
            <p:nvPr/>
          </p:nvSpPr>
          <p:spPr>
            <a:xfrm flipH="1">
              <a:off x="9120050" y="1006080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2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xmlns="" id="{432FBF3B-E3F8-5D04-D990-55C5F1EE8E55}"/>
                </a:ext>
              </a:extLst>
            </p:cNvPr>
            <p:cNvGrpSpPr/>
            <p:nvPr/>
          </p:nvGrpSpPr>
          <p:grpSpPr>
            <a:xfrm>
              <a:off x="1892203" y="1654552"/>
              <a:ext cx="228980" cy="2020433"/>
              <a:chOff x="882483" y="1839263"/>
              <a:chExt cx="228980" cy="2020433"/>
            </a:xfrm>
          </p:grpSpPr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xmlns="" id="{E2A42F8D-BD2A-6592-AC47-B8F765AA10E2}"/>
                  </a:ext>
                </a:extLst>
              </p:cNvPr>
              <p:cNvGrpSpPr/>
              <p:nvPr/>
            </p:nvGrpSpPr>
            <p:grpSpPr>
              <a:xfrm>
                <a:off x="882483" y="2605314"/>
                <a:ext cx="212018" cy="1254382"/>
                <a:chOff x="6994114" y="4520078"/>
                <a:chExt cx="212018" cy="1254382"/>
              </a:xfrm>
            </p:grpSpPr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xmlns="" id="{5674D55C-2743-DCFD-8653-40A8F345ACE1}"/>
                    </a:ext>
                  </a:extLst>
                </p:cNvPr>
                <p:cNvSpPr txBox="1"/>
                <p:nvPr/>
              </p:nvSpPr>
              <p:spPr>
                <a:xfrm>
                  <a:off x="7064646" y="5620572"/>
                  <a:ext cx="141064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>
                      <a:solidFill>
                        <a:schemeClr val="tx1"/>
                      </a:solidFill>
                    </a:rPr>
                    <a:t>50</a:t>
                  </a:r>
                  <a:endParaRPr lang="ja-JP" altLang="en-US" sz="10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xmlns="" id="{DAB9D0F0-0E7E-8E8F-5774-FC1A9BC8709A}"/>
                    </a:ext>
                  </a:extLst>
                </p:cNvPr>
                <p:cNvSpPr txBox="1"/>
                <p:nvPr/>
              </p:nvSpPr>
              <p:spPr>
                <a:xfrm>
                  <a:off x="6994536" y="5072954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/>
                    <a:t>100</a:t>
                  </a:r>
                  <a:endParaRPr lang="ja-JP" altLang="en-US" sz="1000" dirty="0"/>
                </a:p>
              </p:txBody>
            </p: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xmlns="" id="{E37D7132-8F0B-C325-C7B8-6ED93A210328}"/>
                    </a:ext>
                  </a:extLst>
                </p:cNvPr>
                <p:cNvSpPr txBox="1"/>
                <p:nvPr/>
              </p:nvSpPr>
              <p:spPr>
                <a:xfrm>
                  <a:off x="6994114" y="4720238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150</a:t>
                  </a:r>
                  <a:endParaRPr lang="ja-JP" altLang="en-US" sz="1000" dirty="0"/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xmlns="" id="{CC47A6E7-CE78-8AAD-092E-B17CA41B8712}"/>
                    </a:ext>
                  </a:extLst>
                </p:cNvPr>
                <p:cNvSpPr txBox="1"/>
                <p:nvPr/>
              </p:nvSpPr>
              <p:spPr>
                <a:xfrm>
                  <a:off x="6994114" y="4520078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200</a:t>
                  </a:r>
                  <a:endParaRPr lang="ja-JP" altLang="en-US" sz="1000" dirty="0"/>
                </a:p>
              </p:txBody>
            </p:sp>
          </p:grp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xmlns="" id="{B01F8700-37A2-2DF6-9352-2666999D7437}"/>
                  </a:ext>
                </a:extLst>
              </p:cNvPr>
              <p:cNvSpPr txBox="1"/>
              <p:nvPr/>
            </p:nvSpPr>
            <p:spPr>
              <a:xfrm flipH="1">
                <a:off x="888531" y="1839263"/>
                <a:ext cx="22293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bp</a:t>
                </a:r>
                <a:endParaRPr lang="ja-JP" altLang="en-US" sz="1000" dirty="0"/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xmlns="" id="{ECBF9E7A-9CBB-199B-1D82-19813CA384C0}"/>
                </a:ext>
              </a:extLst>
            </p:cNvPr>
            <p:cNvGrpSpPr/>
            <p:nvPr/>
          </p:nvGrpSpPr>
          <p:grpSpPr>
            <a:xfrm>
              <a:off x="4605838" y="4518724"/>
              <a:ext cx="1419251" cy="1286373"/>
              <a:chOff x="3507726" y="4291115"/>
              <a:chExt cx="1419251" cy="1254042"/>
            </a:xfrm>
          </p:grpSpPr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xmlns="" id="{F18F01CC-276D-27B6-3B25-3ABD191B7E2E}"/>
                  </a:ext>
                </a:extLst>
              </p:cNvPr>
              <p:cNvGrpSpPr/>
              <p:nvPr/>
            </p:nvGrpSpPr>
            <p:grpSpPr>
              <a:xfrm>
                <a:off x="3507726" y="4291115"/>
                <a:ext cx="1419251" cy="1254042"/>
                <a:chOff x="7935301" y="1698750"/>
                <a:chExt cx="1882672" cy="1810483"/>
              </a:xfrm>
            </p:grpSpPr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xmlns="" id="{91A03F7B-3ED5-0F2D-FF27-9EE03B124AC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594453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xmlns="" id="{8DD80F1A-3367-1A99-D4DC-65CEA650B4B4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27884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xmlns="" id="{828805D8-CB2C-0DD8-560A-BEB67139F1B6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01663" y="2637382"/>
                  <a:ext cx="1036948" cy="300579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xmlns="" id="{2E018353-D211-471A-5E9C-662BB751F8C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xmlns="" id="{4A5FC116-D230-3EE9-A17A-F61DDF3B7B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55533" y="1980422"/>
                  <a:ext cx="186244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xmlns="" id="{D53F44BC-B2A3-6AF9-8B82-17C8A11F6637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xmlns="" id="{EA51B021-07FA-6791-0D58-D6D157D32D2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42375" y="458054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xmlns="" id="{C6EB74B4-EEBA-A3F2-978F-E2F31FBD595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768594" y="4577758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BB798F9C-E366-2324-CAF6-FB949D83B41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xmlns="" id="{0466ED86-E35B-3D98-1347-66B8E514721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8269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xmlns="" id="{D8DECDAA-CDD9-ED49-5AB1-36B64290AC1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24235" y="4583900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xmlns="" id="{FCCBEE48-AEAC-BE10-0411-0E2C60C04AF7}"/>
                </a:ext>
              </a:extLst>
            </p:cNvPr>
            <p:cNvGrpSpPr/>
            <p:nvPr/>
          </p:nvGrpSpPr>
          <p:grpSpPr>
            <a:xfrm>
              <a:off x="8910588" y="4612318"/>
              <a:ext cx="1341168" cy="1286373"/>
              <a:chOff x="3557836" y="4291115"/>
              <a:chExt cx="1341168" cy="1254042"/>
            </a:xfrm>
          </p:grpSpPr>
          <p:grpSp>
            <p:nvGrpSpPr>
              <p:cNvPr id="31" name="グループ化 30">
                <a:extLst>
                  <a:ext uri="{FF2B5EF4-FFF2-40B4-BE49-F238E27FC236}">
                    <a16:creationId xmlns:a16="http://schemas.microsoft.com/office/drawing/2014/main" xmlns="" id="{DA870EFC-0FFB-0D77-27F9-F9549B225A06}"/>
                  </a:ext>
                </a:extLst>
              </p:cNvPr>
              <p:cNvGrpSpPr/>
              <p:nvPr/>
            </p:nvGrpSpPr>
            <p:grpSpPr>
              <a:xfrm>
                <a:off x="3557836" y="4291115"/>
                <a:ext cx="1341168" cy="1254042"/>
                <a:chOff x="8001775" y="1698750"/>
                <a:chExt cx="1779092" cy="1810483"/>
              </a:xfrm>
            </p:grpSpPr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xmlns="" id="{30F17551-DF0F-3DEA-92FB-129D5484769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660927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xmlns="" id="{EDAA883E-A6ED-00BE-1F49-F59A7C03464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94356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xmlns="" id="{C196EE1F-4D8C-1F2F-F7AC-4ADE23CDC48E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51518" y="2637382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xmlns="" id="{1EE84E5C-4862-5F85-FBFC-21446E3A99F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xmlns="" id="{56691580-11F1-CBFB-8E7E-B3835BC712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13937" y="1980130"/>
                  <a:ext cx="176693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xmlns="" id="{E39A66BD-7357-AC6C-CA07-7E6733C441F0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xmlns="" id="{360BD426-6745-E4D2-BE8B-7FC8A423BA4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79959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xmlns="" id="{D3C7D5F4-4540-10CE-3ADE-A8B9B2A15AB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21838" y="4577757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xmlns="" id="{DE319A40-EA40-3E76-810C-662EC38052A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xmlns="" id="{CE462B6A-8FF0-F982-8B09-E14DE6310A6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6703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xmlns="" id="{1DFB82A6-63E5-EEAB-B9B1-AC3C2686CCD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2311" y="4583899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2893526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xmlns="" id="{830A8D9D-711E-826F-9BFA-33EAD1095462}"/>
              </a:ext>
            </a:extLst>
          </p:cNvPr>
          <p:cNvGrpSpPr/>
          <p:nvPr/>
        </p:nvGrpSpPr>
        <p:grpSpPr>
          <a:xfrm>
            <a:off x="588761" y="765906"/>
            <a:ext cx="4890776" cy="5385911"/>
            <a:chOff x="900992" y="765906"/>
            <a:chExt cx="4890776" cy="5385911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xmlns="" id="{A6202517-3D96-10EB-CB41-54A30A44C1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00432" y="765906"/>
              <a:ext cx="4591336" cy="5385911"/>
            </a:xfrm>
            <a:prstGeom prst="rect">
              <a:avLst/>
            </a:prstGeom>
          </p:spPr>
        </p:pic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B133C276-DFE3-152F-9C91-43F9DAD8C969}"/>
                </a:ext>
              </a:extLst>
            </p:cNvPr>
            <p:cNvSpPr txBox="1"/>
            <p:nvPr/>
          </p:nvSpPr>
          <p:spPr>
            <a:xfrm flipH="1">
              <a:off x="3794904" y="1056956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xmlns="" id="{B16A4CD2-FA43-73B7-AE0A-1B3977900BDD}"/>
                </a:ext>
              </a:extLst>
            </p:cNvPr>
            <p:cNvGrpSpPr/>
            <p:nvPr/>
          </p:nvGrpSpPr>
          <p:grpSpPr>
            <a:xfrm>
              <a:off x="3595631" y="4274699"/>
              <a:ext cx="1367997" cy="1286373"/>
              <a:chOff x="3583048" y="4291115"/>
              <a:chExt cx="1367997" cy="1254042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xmlns="" id="{2A28D399-CFF7-4415-61A1-11EA8214255D}"/>
                  </a:ext>
                </a:extLst>
              </p:cNvPr>
              <p:cNvGrpSpPr/>
              <p:nvPr/>
            </p:nvGrpSpPr>
            <p:grpSpPr>
              <a:xfrm>
                <a:off x="3583048" y="4291115"/>
                <a:ext cx="1367997" cy="1254042"/>
                <a:chOff x="8035217" y="1698750"/>
                <a:chExt cx="1814681" cy="1810483"/>
              </a:xfrm>
            </p:grpSpPr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xmlns="" id="{5F809DBB-2FE5-E1E2-5FA6-9404CEB88B44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703488" y="2615641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xmlns="" id="{F0073B92-A3B7-FF4B-EA5E-14E5CB1F3A70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136916" y="2641130"/>
                  <a:ext cx="1231490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xmlns="" id="{E33C5A10-B4A2-7237-F59F-FD0B3270B0EF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94078" y="2659960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xmlns="" id="{0E554069-35EA-6B41-A50D-547B6D8BE00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9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" name="直線コネクタ 9">
                  <a:extLst>
                    <a:ext uri="{FF2B5EF4-FFF2-40B4-BE49-F238E27FC236}">
                      <a16:creationId xmlns:a16="http://schemas.microsoft.com/office/drawing/2014/main" xmlns="" id="{091246EF-6A90-3FA9-9808-6338777E7A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35217" y="1980129"/>
                  <a:ext cx="1814681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xmlns="" id="{9EE31766-05C2-8D2F-632A-0745FA2C0D0D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13F9C770-03C9-3F71-811D-ED11047E9D4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504022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xmlns="" id="{BCE19582-551C-853F-95BA-C4187FA9484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61943" y="457775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xmlns="" id="{158FE997-586F-BCDA-BB07-19B4C454771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203098" y="4585022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xmlns="" id="{4C75BD8C-8101-98BE-0CE6-5381AAE504F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38650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xmlns="" id="{27899BB5-9F25-E7DC-785F-910A30EA79E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50437" y="4583898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xmlns="" id="{9B32E488-764F-30A6-B9D9-FC96A44756F0}"/>
                </a:ext>
              </a:extLst>
            </p:cNvPr>
            <p:cNvGrpSpPr/>
            <p:nvPr/>
          </p:nvGrpSpPr>
          <p:grpSpPr>
            <a:xfrm>
              <a:off x="900992" y="1921486"/>
              <a:ext cx="247511" cy="1643304"/>
              <a:chOff x="871872" y="2213785"/>
              <a:chExt cx="247511" cy="1643304"/>
            </a:xfrm>
          </p:grpSpPr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xmlns="" id="{662A5C88-47A2-5F32-DCB0-795232250478}"/>
                  </a:ext>
                </a:extLst>
              </p:cNvPr>
              <p:cNvGrpSpPr/>
              <p:nvPr/>
            </p:nvGrpSpPr>
            <p:grpSpPr>
              <a:xfrm>
                <a:off x="871872" y="2669645"/>
                <a:ext cx="217226" cy="1187444"/>
                <a:chOff x="6983503" y="4584409"/>
                <a:chExt cx="217226" cy="1187444"/>
              </a:xfrm>
            </p:grpSpPr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xmlns="" id="{EF557D12-AE49-515F-B162-4ED882A3D78E}"/>
                    </a:ext>
                  </a:extLst>
                </p:cNvPr>
                <p:cNvSpPr txBox="1"/>
                <p:nvPr/>
              </p:nvSpPr>
              <p:spPr>
                <a:xfrm>
                  <a:off x="7054035" y="5617965"/>
                  <a:ext cx="141064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>
                      <a:solidFill>
                        <a:schemeClr val="tx1"/>
                      </a:solidFill>
                    </a:rPr>
                    <a:t>50</a:t>
                  </a:r>
                  <a:endParaRPr lang="ja-JP" altLang="en-US" sz="10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xmlns="" id="{CFB8C2CC-A087-5EEF-130C-27635F634F29}"/>
                    </a:ext>
                  </a:extLst>
                </p:cNvPr>
                <p:cNvSpPr txBox="1"/>
                <p:nvPr/>
              </p:nvSpPr>
              <p:spPr>
                <a:xfrm>
                  <a:off x="6989133" y="5110854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ct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r"/>
                  <a:r>
                    <a:rPr lang="en-US" altLang="ja-JP" sz="1000" dirty="0"/>
                    <a:t>100</a:t>
                  </a:r>
                  <a:endParaRPr lang="ja-JP" altLang="en-US" sz="1000" dirty="0"/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xmlns="" id="{B3933FE7-53F4-EB94-B9DF-716D0EF5637E}"/>
                    </a:ext>
                  </a:extLst>
                </p:cNvPr>
                <p:cNvSpPr txBox="1"/>
                <p:nvPr/>
              </p:nvSpPr>
              <p:spPr>
                <a:xfrm>
                  <a:off x="6984382" y="4788866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150</a:t>
                  </a:r>
                  <a:endParaRPr lang="ja-JP" altLang="en-US" sz="1000" dirty="0"/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xmlns="" id="{B7491A4A-A58E-0239-B5A1-EBD7B693C8C0}"/>
                    </a:ext>
                  </a:extLst>
                </p:cNvPr>
                <p:cNvSpPr txBox="1"/>
                <p:nvPr/>
              </p:nvSpPr>
              <p:spPr>
                <a:xfrm>
                  <a:off x="6983503" y="4584409"/>
                  <a:ext cx="211596" cy="15388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200</a:t>
                  </a:r>
                  <a:endParaRPr lang="ja-JP" altLang="en-US" sz="1000" dirty="0"/>
                </a:p>
              </p:txBody>
            </p:sp>
          </p:grp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xmlns="" id="{A5B1C544-6FC3-6895-3E20-C74697943481}"/>
                  </a:ext>
                </a:extLst>
              </p:cNvPr>
              <p:cNvSpPr txBox="1"/>
              <p:nvPr/>
            </p:nvSpPr>
            <p:spPr>
              <a:xfrm flipH="1">
                <a:off x="896451" y="2213785"/>
                <a:ext cx="22293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bp</a:t>
                </a:r>
                <a:endParaRPr lang="ja-JP" altLang="en-US" sz="1000" dirty="0"/>
              </a:p>
            </p:txBody>
          </p:sp>
        </p:grp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xmlns="" id="{83A2A98E-906A-218D-9B3B-DA27CE12DBFC}"/>
              </a:ext>
            </a:extLst>
          </p:cNvPr>
          <p:cNvGrpSpPr/>
          <p:nvPr/>
        </p:nvGrpSpPr>
        <p:grpSpPr>
          <a:xfrm>
            <a:off x="6451323" y="765906"/>
            <a:ext cx="4769153" cy="5385911"/>
            <a:chOff x="6451323" y="765906"/>
            <a:chExt cx="4769153" cy="5385911"/>
          </a:xfrm>
        </p:grpSpPr>
        <p:pic>
          <p:nvPicPr>
            <p:cNvPr id="42" name="図 41">
              <a:extLst>
                <a:ext uri="{FF2B5EF4-FFF2-40B4-BE49-F238E27FC236}">
                  <a16:creationId xmlns:a16="http://schemas.microsoft.com/office/drawing/2014/main" xmlns="" id="{685573D3-8D24-3B76-224F-18E43AE9CDB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702864" y="765906"/>
              <a:ext cx="4517612" cy="5385911"/>
            </a:xfrm>
            <a:prstGeom prst="rect">
              <a:avLst/>
            </a:prstGeom>
          </p:spPr>
        </p:pic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F036B966-F306-5087-B7BC-C82B4860E261}"/>
                </a:ext>
              </a:extLst>
            </p:cNvPr>
            <p:cNvSpPr txBox="1"/>
            <p:nvPr/>
          </p:nvSpPr>
          <p:spPr>
            <a:xfrm flipH="1">
              <a:off x="9552416" y="1081340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DH1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xmlns="" id="{4F93EF47-7E17-C22B-CFEA-6AA24355C280}"/>
                </a:ext>
              </a:extLst>
            </p:cNvPr>
            <p:cNvGrpSpPr/>
            <p:nvPr/>
          </p:nvGrpSpPr>
          <p:grpSpPr>
            <a:xfrm>
              <a:off x="6451323" y="1968717"/>
              <a:ext cx="247511" cy="1623288"/>
              <a:chOff x="387641" y="2073886"/>
              <a:chExt cx="247511" cy="1623288"/>
            </a:xfrm>
          </p:grpSpPr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xmlns="" id="{C12FD8DE-187D-34D5-615D-24A0BB07D64A}"/>
                  </a:ext>
                </a:extLst>
              </p:cNvPr>
              <p:cNvSpPr txBox="1"/>
              <p:nvPr/>
            </p:nvSpPr>
            <p:spPr>
              <a:xfrm>
                <a:off x="388520" y="2734203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150</a:t>
                </a:r>
                <a:endParaRPr lang="ja-JP" altLang="en-US" sz="1000" dirty="0"/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xmlns="" id="{4456F214-8300-9226-F000-FDBAECB68542}"/>
                  </a:ext>
                </a:extLst>
              </p:cNvPr>
              <p:cNvSpPr txBox="1"/>
              <p:nvPr/>
            </p:nvSpPr>
            <p:spPr>
              <a:xfrm>
                <a:off x="387641" y="2529746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200</a:t>
                </a:r>
                <a:endParaRPr lang="ja-JP" altLang="en-US" sz="1000" dirty="0"/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xmlns="" id="{629434D6-9027-A5E0-DFC7-37620AD540D4}"/>
                  </a:ext>
                </a:extLst>
              </p:cNvPr>
              <p:cNvSpPr txBox="1"/>
              <p:nvPr/>
            </p:nvSpPr>
            <p:spPr>
              <a:xfrm>
                <a:off x="452543" y="3543286"/>
                <a:ext cx="141064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ctr">
                  <a:defRPr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r"/>
                <a:r>
                  <a:rPr lang="en-US" altLang="ja-JP" sz="1000" dirty="0">
                    <a:solidFill>
                      <a:schemeClr val="tx1"/>
                    </a:solidFill>
                  </a:rPr>
                  <a:t>50</a:t>
                </a:r>
                <a:endParaRPr lang="ja-JP" altLang="en-US" sz="10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xmlns="" id="{FA7B1F80-35BB-F6C2-8951-7EDE48CD82E7}"/>
                  </a:ext>
                </a:extLst>
              </p:cNvPr>
              <p:cNvSpPr txBox="1"/>
              <p:nvPr/>
            </p:nvSpPr>
            <p:spPr>
              <a:xfrm>
                <a:off x="387641" y="3036175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ct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pPr algn="r"/>
                <a:r>
                  <a:rPr lang="en-US" altLang="ja-JP" sz="1000" dirty="0"/>
                  <a:t>100</a:t>
                </a:r>
                <a:endParaRPr lang="ja-JP" altLang="en-US" sz="1000" dirty="0"/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xmlns="" id="{7128C90F-DD27-1E85-FB0B-101C669EE18F}"/>
                  </a:ext>
                </a:extLst>
              </p:cNvPr>
              <p:cNvSpPr txBox="1"/>
              <p:nvPr/>
            </p:nvSpPr>
            <p:spPr>
              <a:xfrm flipH="1">
                <a:off x="412220" y="2073886"/>
                <a:ext cx="22293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bp</a:t>
                </a:r>
                <a:endParaRPr lang="ja-JP" altLang="en-US" sz="1000" dirty="0"/>
              </a:p>
            </p:txBody>
          </p:sp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xmlns="" id="{78583247-A265-639B-882D-4B4F02948387}"/>
                </a:ext>
              </a:extLst>
            </p:cNvPr>
            <p:cNvGrpSpPr/>
            <p:nvPr/>
          </p:nvGrpSpPr>
          <p:grpSpPr>
            <a:xfrm>
              <a:off x="9198744" y="4225931"/>
              <a:ext cx="1367997" cy="1286373"/>
              <a:chOff x="3583048" y="4291115"/>
              <a:chExt cx="1367997" cy="1254042"/>
            </a:xfrm>
          </p:grpSpPr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xmlns="" id="{4103B41C-80F9-2B6C-79A4-970D0C2A1CB0}"/>
                  </a:ext>
                </a:extLst>
              </p:cNvPr>
              <p:cNvGrpSpPr/>
              <p:nvPr/>
            </p:nvGrpSpPr>
            <p:grpSpPr>
              <a:xfrm>
                <a:off x="3583048" y="4291115"/>
                <a:ext cx="1367997" cy="1254042"/>
                <a:chOff x="8035217" y="1698750"/>
                <a:chExt cx="1814681" cy="1810483"/>
              </a:xfrm>
            </p:grpSpPr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xmlns="" id="{6C1415F9-0AE2-A67E-70C8-DC412F0A806B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703488" y="2615641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xmlns="" id="{FE186734-9AC6-8442-C146-A1D4339FD3CD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136916" y="2641130"/>
                  <a:ext cx="1231490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xmlns="" id="{F580836B-3542-EAE5-1054-4FB7EEE56858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94078" y="2659960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xmlns="" id="{78142D80-846B-ECF4-88A5-B95AA64EB878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9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3" name="直線コネクタ 62">
                  <a:extLst>
                    <a:ext uri="{FF2B5EF4-FFF2-40B4-BE49-F238E27FC236}">
                      <a16:creationId xmlns:a16="http://schemas.microsoft.com/office/drawing/2014/main" xmlns="" id="{DCC191EB-77B2-C0F6-8DA7-71A6349E66E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35217" y="1980129"/>
                  <a:ext cx="1814681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xmlns="" id="{F918B192-5BED-A7BF-7D38-E8FB7F40636C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xmlns="" id="{515387A7-FE86-CCE5-C436-A802F9B5DF9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504022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xmlns="" id="{FA1610F3-DA34-C173-C86F-58136E88739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61943" y="457775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xmlns="" id="{DB3AC635-C7A6-FE82-2D6F-4F0AFD0C4C9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203098" y="4585022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xmlns="" id="{F94A3F0E-DB20-D458-9870-B61A621D1FC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38650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xmlns="" id="{0FD61A8C-7350-75BC-1ACB-F15E9E6CAFB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50437" y="4583898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85588F6A-5A62-B9EF-AE55-31A30C905B5E}"/>
              </a:ext>
            </a:extLst>
          </p:cNvPr>
          <p:cNvSpPr txBox="1"/>
          <p:nvPr/>
        </p:nvSpPr>
        <p:spPr>
          <a:xfrm>
            <a:off x="243893" y="105891"/>
            <a:ext cx="55659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of Fig. 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4 lanes shown as 4-week were used in Figure 6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47219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xmlns="" id="{B0ED8500-3487-7315-1855-A589EC6C18B3}"/>
              </a:ext>
            </a:extLst>
          </p:cNvPr>
          <p:cNvGrpSpPr/>
          <p:nvPr/>
        </p:nvGrpSpPr>
        <p:grpSpPr>
          <a:xfrm>
            <a:off x="911483" y="918457"/>
            <a:ext cx="4884397" cy="5385435"/>
            <a:chOff x="911483" y="918457"/>
            <a:chExt cx="4884397" cy="5385435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xmlns="" id="{A140AADA-30F5-1519-27D9-D9CFF986EF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81589" y="918457"/>
              <a:ext cx="4614291" cy="5385435"/>
            </a:xfrm>
            <a:prstGeom prst="rect">
              <a:avLst/>
            </a:prstGeom>
          </p:spPr>
        </p:pic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B133C276-DFE3-152F-9C91-43F9DAD8C969}"/>
                </a:ext>
              </a:extLst>
            </p:cNvPr>
            <p:cNvSpPr txBox="1"/>
            <p:nvPr/>
          </p:nvSpPr>
          <p:spPr>
            <a:xfrm flipH="1">
              <a:off x="3794904" y="1056956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33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xmlns="" id="{B16A4CD2-FA43-73B7-AE0A-1B3977900BDD}"/>
                </a:ext>
              </a:extLst>
            </p:cNvPr>
            <p:cNvGrpSpPr/>
            <p:nvPr/>
          </p:nvGrpSpPr>
          <p:grpSpPr>
            <a:xfrm>
              <a:off x="3570419" y="4274699"/>
              <a:ext cx="1341168" cy="1286373"/>
              <a:chOff x="3557836" y="4291115"/>
              <a:chExt cx="1341168" cy="1254042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xmlns="" id="{2A28D399-CFF7-4415-61A1-11EA8214255D}"/>
                  </a:ext>
                </a:extLst>
              </p:cNvPr>
              <p:cNvGrpSpPr/>
              <p:nvPr/>
            </p:nvGrpSpPr>
            <p:grpSpPr>
              <a:xfrm>
                <a:off x="3557836" y="4291115"/>
                <a:ext cx="1341168" cy="1254042"/>
                <a:chOff x="8001775" y="1698750"/>
                <a:chExt cx="1779092" cy="1810483"/>
              </a:xfrm>
            </p:grpSpPr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xmlns="" id="{5F809DBB-2FE5-E1E2-5FA6-9404CEB88B44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660927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xmlns="" id="{F0073B92-A3B7-FF4B-EA5E-14E5CB1F3A70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94356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xmlns="" id="{E33C5A10-B4A2-7237-F59F-FD0B3270B0EF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51518" y="2637382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xmlns="" id="{0E554069-35EA-6B41-A50D-547B6D8BE00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" name="直線コネクタ 9">
                  <a:extLst>
                    <a:ext uri="{FF2B5EF4-FFF2-40B4-BE49-F238E27FC236}">
                      <a16:creationId xmlns:a16="http://schemas.microsoft.com/office/drawing/2014/main" xmlns="" id="{091246EF-6A90-3FA9-9808-6338777E7A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13937" y="1980130"/>
                  <a:ext cx="176693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xmlns="" id="{9EE31766-05C2-8D2F-632A-0745FA2C0D0D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13F9C770-03C9-3F71-811D-ED11047E9D4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79959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xmlns="" id="{BCE19582-551C-853F-95BA-C4187FA9484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21838" y="4577757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xmlns="" id="{158FE997-586F-BCDA-BB07-19B4C454771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65937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xmlns="" id="{4C75BD8C-8101-98BE-0CE6-5381AAE504F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90524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xmlns="" id="{27899BB5-9F25-E7DC-785F-910A30EA79E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2311" y="4583899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xmlns="" id="{635D7594-0C09-F84F-497C-28BE0CC23059}"/>
                </a:ext>
              </a:extLst>
            </p:cNvPr>
            <p:cNvGrpSpPr/>
            <p:nvPr/>
          </p:nvGrpSpPr>
          <p:grpSpPr>
            <a:xfrm>
              <a:off x="911483" y="2181041"/>
              <a:ext cx="228980" cy="2231444"/>
              <a:chOff x="911483" y="2181041"/>
              <a:chExt cx="228980" cy="2231444"/>
            </a:xfrm>
          </p:grpSpPr>
          <p:grpSp>
            <p:nvGrpSpPr>
              <p:cNvPr id="38" name="グループ化 37">
                <a:extLst>
                  <a:ext uri="{FF2B5EF4-FFF2-40B4-BE49-F238E27FC236}">
                    <a16:creationId xmlns:a16="http://schemas.microsoft.com/office/drawing/2014/main" xmlns="" id="{9B32E488-764F-30A6-B9D9-FC96A44756F0}"/>
                  </a:ext>
                </a:extLst>
              </p:cNvPr>
              <p:cNvGrpSpPr/>
              <p:nvPr/>
            </p:nvGrpSpPr>
            <p:grpSpPr>
              <a:xfrm>
                <a:off x="911483" y="2181041"/>
                <a:ext cx="228980" cy="2231444"/>
                <a:chOff x="882483" y="1628252"/>
                <a:chExt cx="228980" cy="2231444"/>
              </a:xfrm>
            </p:grpSpPr>
            <p:grpSp>
              <p:nvGrpSpPr>
                <p:cNvPr id="36" name="グループ化 35">
                  <a:extLst>
                    <a:ext uri="{FF2B5EF4-FFF2-40B4-BE49-F238E27FC236}">
                      <a16:creationId xmlns:a16="http://schemas.microsoft.com/office/drawing/2014/main" xmlns="" id="{662A5C88-47A2-5F32-DCB0-795232250478}"/>
                    </a:ext>
                  </a:extLst>
                </p:cNvPr>
                <p:cNvGrpSpPr/>
                <p:nvPr/>
              </p:nvGrpSpPr>
              <p:grpSpPr>
                <a:xfrm>
                  <a:off x="882483" y="2293182"/>
                  <a:ext cx="212018" cy="1566514"/>
                  <a:chOff x="6994114" y="4207946"/>
                  <a:chExt cx="212018" cy="1566514"/>
                </a:xfrm>
              </p:grpSpPr>
              <p:sp>
                <p:nvSpPr>
                  <p:cNvPr id="32" name="テキスト ボックス 31">
                    <a:extLst>
                      <a:ext uri="{FF2B5EF4-FFF2-40B4-BE49-F238E27FC236}">
                        <a16:creationId xmlns:a16="http://schemas.microsoft.com/office/drawing/2014/main" xmlns="" id="{EF557D12-AE49-515F-B162-4ED882A3D78E}"/>
                      </a:ext>
                    </a:extLst>
                  </p:cNvPr>
                  <p:cNvSpPr txBox="1"/>
                  <p:nvPr/>
                </p:nvSpPr>
                <p:spPr>
                  <a:xfrm>
                    <a:off x="7064646" y="5620572"/>
                    <a:ext cx="141064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ctr">
                      <a:defRPr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pPr algn="r"/>
                    <a:r>
                      <a:rPr lang="en-US" altLang="ja-JP" sz="1000" dirty="0">
                        <a:solidFill>
                          <a:schemeClr val="tx1"/>
                        </a:solidFill>
                      </a:rPr>
                      <a:t>50</a:t>
                    </a:r>
                    <a:endParaRPr lang="ja-JP" altLang="en-US" sz="10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3" name="テキスト ボックス 32">
                    <a:extLst>
                      <a:ext uri="{FF2B5EF4-FFF2-40B4-BE49-F238E27FC236}">
                        <a16:creationId xmlns:a16="http://schemas.microsoft.com/office/drawing/2014/main" xmlns="" id="{CFB8C2CC-A087-5EEF-130C-27635F634F29}"/>
                      </a:ext>
                    </a:extLst>
                  </p:cNvPr>
                  <p:cNvSpPr txBox="1"/>
                  <p:nvPr/>
                </p:nvSpPr>
                <p:spPr>
                  <a:xfrm>
                    <a:off x="6994536" y="4947911"/>
                    <a:ext cx="211596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ctr">
                      <a:defRPr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pPr algn="r"/>
                    <a:r>
                      <a:rPr lang="en-US" altLang="ja-JP" sz="1000" dirty="0"/>
                      <a:t>100</a:t>
                    </a:r>
                    <a:endParaRPr lang="ja-JP" altLang="en-US" sz="1000" dirty="0"/>
                  </a:p>
                </p:txBody>
              </p:sp>
              <p:sp>
                <p:nvSpPr>
                  <p:cNvPr id="34" name="テキスト ボックス 33">
                    <a:extLst>
                      <a:ext uri="{FF2B5EF4-FFF2-40B4-BE49-F238E27FC236}">
                        <a16:creationId xmlns:a16="http://schemas.microsoft.com/office/drawing/2014/main" xmlns="" id="{B3933FE7-53F4-EB94-B9DF-716D0EF5637E}"/>
                      </a:ext>
                    </a:extLst>
                  </p:cNvPr>
                  <p:cNvSpPr txBox="1"/>
                  <p:nvPr/>
                </p:nvSpPr>
                <p:spPr>
                  <a:xfrm>
                    <a:off x="6994114" y="4509267"/>
                    <a:ext cx="211596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r">
                      <a:defRPr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ja-JP" sz="1000" dirty="0"/>
                      <a:t>150</a:t>
                    </a:r>
                    <a:endParaRPr lang="ja-JP" altLang="en-US" sz="1000" dirty="0"/>
                  </a:p>
                </p:txBody>
              </p:sp>
              <p:sp>
                <p:nvSpPr>
                  <p:cNvPr id="35" name="テキスト ボックス 34">
                    <a:extLst>
                      <a:ext uri="{FF2B5EF4-FFF2-40B4-BE49-F238E27FC236}">
                        <a16:creationId xmlns:a16="http://schemas.microsoft.com/office/drawing/2014/main" xmlns="" id="{B7491A4A-A58E-0239-B5A1-EBD7B693C8C0}"/>
                      </a:ext>
                    </a:extLst>
                  </p:cNvPr>
                  <p:cNvSpPr txBox="1"/>
                  <p:nvPr/>
                </p:nvSpPr>
                <p:spPr>
                  <a:xfrm>
                    <a:off x="6994114" y="4207946"/>
                    <a:ext cx="211596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r">
                      <a:defRPr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ja-JP" sz="1000" dirty="0"/>
                      <a:t>200</a:t>
                    </a:r>
                    <a:endParaRPr lang="ja-JP" altLang="en-US" sz="1000" dirty="0"/>
                  </a:p>
                </p:txBody>
              </p:sp>
            </p:grp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xmlns="" id="{A5B1C544-6FC3-6895-3E20-C74697943481}"/>
                    </a:ext>
                  </a:extLst>
                </p:cNvPr>
                <p:cNvSpPr txBox="1"/>
                <p:nvPr/>
              </p:nvSpPr>
              <p:spPr>
                <a:xfrm flipH="1">
                  <a:off x="888531" y="1628252"/>
                  <a:ext cx="2229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bp</a:t>
                  </a:r>
                  <a:endParaRPr lang="ja-JP" altLang="en-US" sz="1000" dirty="0"/>
                </a:p>
              </p:txBody>
            </p:sp>
          </p:grp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xmlns="" id="{F642EB26-F5AA-7EC6-6BC8-057A47513F1F}"/>
                  </a:ext>
                </a:extLst>
              </p:cNvPr>
              <p:cNvSpPr txBox="1"/>
              <p:nvPr/>
            </p:nvSpPr>
            <p:spPr>
              <a:xfrm>
                <a:off x="912967" y="2688097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250</a:t>
                </a:r>
                <a:endParaRPr lang="ja-JP" altLang="en-US" sz="1000" dirty="0"/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xmlns="" id="{D006E288-FA8E-DFE4-CDB5-7B3E055E3634}"/>
                  </a:ext>
                </a:extLst>
              </p:cNvPr>
              <p:cNvSpPr txBox="1"/>
              <p:nvPr/>
            </p:nvSpPr>
            <p:spPr>
              <a:xfrm>
                <a:off x="911483" y="2542741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300</a:t>
                </a:r>
                <a:endParaRPr lang="ja-JP" altLang="en-US" sz="1000" dirty="0"/>
              </a:p>
            </p:txBody>
          </p:sp>
        </p:grpSp>
      </p:grp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F9F5641C-36EB-44D2-18C6-9D39EC36F65E}"/>
              </a:ext>
            </a:extLst>
          </p:cNvPr>
          <p:cNvSpPr txBox="1"/>
          <p:nvPr/>
        </p:nvSpPr>
        <p:spPr>
          <a:xfrm>
            <a:off x="243893" y="172797"/>
            <a:ext cx="55659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of Fig. 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4 lanes shown as 4-week were used in Figure 6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15456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92828512-FDBB-698E-A69E-2C2C0D50F1ED}"/>
              </a:ext>
            </a:extLst>
          </p:cNvPr>
          <p:cNvSpPr txBox="1"/>
          <p:nvPr/>
        </p:nvSpPr>
        <p:spPr>
          <a:xfrm>
            <a:off x="243893" y="172797"/>
            <a:ext cx="55659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of Fig. 6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e 4 lanes shown as 4-week were used in Figure 6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xmlns="" id="{F68DA1EC-7499-FC0C-17A6-C0D36F646D1C}"/>
              </a:ext>
            </a:extLst>
          </p:cNvPr>
          <p:cNvGrpSpPr/>
          <p:nvPr/>
        </p:nvGrpSpPr>
        <p:grpSpPr>
          <a:xfrm>
            <a:off x="1787696" y="805051"/>
            <a:ext cx="9782158" cy="5536311"/>
            <a:chOff x="1787696" y="1037065"/>
            <a:chExt cx="9782158" cy="5536311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xmlns="" id="{B70E73C2-EA3B-A0DE-18C4-1C2CB44EBB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10767" y="1037065"/>
              <a:ext cx="9459087" cy="5536311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xmlns="" id="{5A9C7FBF-9794-2EA5-2B5F-9EC2C5C5EF68}"/>
                </a:ext>
              </a:extLst>
            </p:cNvPr>
            <p:cNvSpPr txBox="1"/>
            <p:nvPr/>
          </p:nvSpPr>
          <p:spPr>
            <a:xfrm flipH="1">
              <a:off x="4821351" y="1287455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NA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xmlns="" id="{139AA282-1E39-486A-7C54-CB170AC490B1}"/>
                </a:ext>
              </a:extLst>
            </p:cNvPr>
            <p:cNvSpPr txBox="1"/>
            <p:nvPr/>
          </p:nvSpPr>
          <p:spPr>
            <a:xfrm flipH="1">
              <a:off x="8983570" y="1265391"/>
              <a:ext cx="972185" cy="349702"/>
            </a:xfrm>
            <a:prstGeom prst="rect">
              <a:avLst/>
            </a:prstGeom>
            <a:noFill/>
          </p:spPr>
          <p:txBody>
            <a:bodyPr wrap="square" lIns="36000" tIns="36000" rIns="36000" bIns="36000" rtlCol="0" anchor="ctr" anchorCtr="1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kumimoji="1" lang="ja-JP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xmlns="" id="{4D56A5BC-B4B8-05D4-C47C-22FCFCF55EAF}"/>
                </a:ext>
              </a:extLst>
            </p:cNvPr>
            <p:cNvGrpSpPr/>
            <p:nvPr/>
          </p:nvGrpSpPr>
          <p:grpSpPr>
            <a:xfrm>
              <a:off x="1787696" y="2291368"/>
              <a:ext cx="228980" cy="2020433"/>
              <a:chOff x="911483" y="2392052"/>
              <a:chExt cx="228980" cy="2020433"/>
            </a:xfrm>
          </p:grpSpPr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xmlns="" id="{432FBF3B-E3F8-5D04-D990-55C5F1EE8E55}"/>
                  </a:ext>
                </a:extLst>
              </p:cNvPr>
              <p:cNvGrpSpPr/>
              <p:nvPr/>
            </p:nvGrpSpPr>
            <p:grpSpPr>
              <a:xfrm>
                <a:off x="911483" y="2392052"/>
                <a:ext cx="228980" cy="2020433"/>
                <a:chOff x="882483" y="1839263"/>
                <a:chExt cx="228980" cy="2020433"/>
              </a:xfrm>
            </p:grpSpPr>
            <p:grpSp>
              <p:nvGrpSpPr>
                <p:cNvPr id="11" name="グループ化 10">
                  <a:extLst>
                    <a:ext uri="{FF2B5EF4-FFF2-40B4-BE49-F238E27FC236}">
                      <a16:creationId xmlns:a16="http://schemas.microsoft.com/office/drawing/2014/main" xmlns="" id="{E2A42F8D-BD2A-6592-AC47-B8F765AA10E2}"/>
                    </a:ext>
                  </a:extLst>
                </p:cNvPr>
                <p:cNvGrpSpPr/>
                <p:nvPr/>
              </p:nvGrpSpPr>
              <p:grpSpPr>
                <a:xfrm>
                  <a:off x="882483" y="2605314"/>
                  <a:ext cx="212018" cy="1254382"/>
                  <a:chOff x="6994114" y="4520078"/>
                  <a:chExt cx="212018" cy="1254382"/>
                </a:xfrm>
              </p:grpSpPr>
              <p:sp>
                <p:nvSpPr>
                  <p:cNvPr id="13" name="テキスト ボックス 12">
                    <a:extLst>
                      <a:ext uri="{FF2B5EF4-FFF2-40B4-BE49-F238E27FC236}">
                        <a16:creationId xmlns:a16="http://schemas.microsoft.com/office/drawing/2014/main" xmlns="" id="{5674D55C-2743-DCFD-8653-40A8F345ACE1}"/>
                      </a:ext>
                    </a:extLst>
                  </p:cNvPr>
                  <p:cNvSpPr txBox="1"/>
                  <p:nvPr/>
                </p:nvSpPr>
                <p:spPr>
                  <a:xfrm>
                    <a:off x="7064646" y="5620572"/>
                    <a:ext cx="141064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ctr">
                      <a:defRPr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pPr algn="r"/>
                    <a:r>
                      <a:rPr lang="en-US" altLang="ja-JP" sz="1000" dirty="0">
                        <a:solidFill>
                          <a:schemeClr val="tx1"/>
                        </a:solidFill>
                      </a:rPr>
                      <a:t>50</a:t>
                    </a:r>
                    <a:endParaRPr lang="ja-JP" altLang="en-US" sz="1000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4" name="テキスト ボックス 13">
                    <a:extLst>
                      <a:ext uri="{FF2B5EF4-FFF2-40B4-BE49-F238E27FC236}">
                        <a16:creationId xmlns:a16="http://schemas.microsoft.com/office/drawing/2014/main" xmlns="" id="{DAB9D0F0-0E7E-8E8F-5774-FC1A9BC8709A}"/>
                      </a:ext>
                    </a:extLst>
                  </p:cNvPr>
                  <p:cNvSpPr txBox="1"/>
                  <p:nvPr/>
                </p:nvSpPr>
                <p:spPr>
                  <a:xfrm>
                    <a:off x="6994536" y="5072954"/>
                    <a:ext cx="211596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ctr">
                      <a:defRPr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pPr algn="r"/>
                    <a:r>
                      <a:rPr lang="en-US" altLang="ja-JP" sz="1000" dirty="0"/>
                      <a:t>100</a:t>
                    </a:r>
                    <a:endParaRPr lang="ja-JP" altLang="en-US" sz="1000" dirty="0"/>
                  </a:p>
                </p:txBody>
              </p:sp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xmlns="" id="{E37D7132-8F0B-C325-C7B8-6ED93A210328}"/>
                      </a:ext>
                    </a:extLst>
                  </p:cNvPr>
                  <p:cNvSpPr txBox="1"/>
                  <p:nvPr/>
                </p:nvSpPr>
                <p:spPr>
                  <a:xfrm>
                    <a:off x="6994114" y="4720238"/>
                    <a:ext cx="211596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r">
                      <a:defRPr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ja-JP" sz="1000" dirty="0"/>
                      <a:t>150</a:t>
                    </a:r>
                    <a:endParaRPr lang="ja-JP" altLang="en-US" sz="1000" dirty="0"/>
                  </a:p>
                </p:txBody>
              </p:sp>
              <p:sp>
                <p:nvSpPr>
                  <p:cNvPr id="16" name="テキスト ボックス 15">
                    <a:extLst>
                      <a:ext uri="{FF2B5EF4-FFF2-40B4-BE49-F238E27FC236}">
                        <a16:creationId xmlns:a16="http://schemas.microsoft.com/office/drawing/2014/main" xmlns="" id="{CC47A6E7-CE78-8AAD-092E-B17CA41B8712}"/>
                      </a:ext>
                    </a:extLst>
                  </p:cNvPr>
                  <p:cNvSpPr txBox="1"/>
                  <p:nvPr/>
                </p:nvSpPr>
                <p:spPr>
                  <a:xfrm>
                    <a:off x="6994114" y="4520078"/>
                    <a:ext cx="211596" cy="153888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 anchor="ctr" anchorCtr="1">
                    <a:spAutoFit/>
                  </a:bodyPr>
                  <a:lstStyle>
                    <a:defPPr>
                      <a:defRPr lang="ja-JP"/>
                    </a:defPPr>
                    <a:lvl1pPr algn="r">
                      <a:defRPr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ja-JP" sz="1000" dirty="0"/>
                      <a:t>200</a:t>
                    </a:r>
                    <a:endParaRPr lang="ja-JP" altLang="en-US" sz="1000" dirty="0"/>
                  </a:p>
                </p:txBody>
              </p:sp>
            </p:grp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xmlns="" id="{B01F8700-37A2-2DF6-9352-2666999D7437}"/>
                    </a:ext>
                  </a:extLst>
                </p:cNvPr>
                <p:cNvSpPr txBox="1"/>
                <p:nvPr/>
              </p:nvSpPr>
              <p:spPr>
                <a:xfrm flipH="1">
                  <a:off x="888531" y="1839263"/>
                  <a:ext cx="2229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>
                  <a:defPPr>
                    <a:defRPr lang="ja-JP"/>
                  </a:defPPr>
                  <a:lvl1pPr algn="r">
                    <a:defRPr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altLang="ja-JP" sz="1000" dirty="0"/>
                    <a:t>bp</a:t>
                  </a:r>
                  <a:endParaRPr lang="ja-JP" altLang="en-US" sz="1000" dirty="0"/>
                </a:p>
              </p:txBody>
            </p:sp>
          </p:grp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xmlns="" id="{83DF9B7F-3028-612B-A3B2-1B47E7D2B3D0}"/>
                  </a:ext>
                </a:extLst>
              </p:cNvPr>
              <p:cNvSpPr txBox="1"/>
              <p:nvPr/>
            </p:nvSpPr>
            <p:spPr>
              <a:xfrm>
                <a:off x="911483" y="2968783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250</a:t>
                </a:r>
                <a:endParaRPr lang="ja-JP" altLang="en-US" sz="1000" dirty="0"/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xmlns="" id="{D123F5A8-A656-2C6E-7FF6-2F0F4551E690}"/>
                  </a:ext>
                </a:extLst>
              </p:cNvPr>
              <p:cNvSpPr txBox="1"/>
              <p:nvPr/>
            </p:nvSpPr>
            <p:spPr>
              <a:xfrm>
                <a:off x="911483" y="2816278"/>
                <a:ext cx="21159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 anchorCtr="1">
                <a:spAutoFit/>
              </a:bodyPr>
              <a:lstStyle>
                <a:defPPr>
                  <a:defRPr lang="ja-JP"/>
                </a:defPPr>
                <a:lvl1pPr algn="r"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ja-JP" sz="1000" dirty="0"/>
                  <a:t>300</a:t>
                </a:r>
                <a:endParaRPr lang="ja-JP" altLang="en-US" sz="1000" dirty="0"/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xmlns="" id="{ECBF9E7A-9CBB-199B-1D82-19813CA384C0}"/>
                </a:ext>
              </a:extLst>
            </p:cNvPr>
            <p:cNvGrpSpPr/>
            <p:nvPr/>
          </p:nvGrpSpPr>
          <p:grpSpPr>
            <a:xfrm>
              <a:off x="4593551" y="4804936"/>
              <a:ext cx="1341168" cy="1286373"/>
              <a:chOff x="3557836" y="4291115"/>
              <a:chExt cx="1341168" cy="1254042"/>
            </a:xfrm>
          </p:grpSpPr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xmlns="" id="{F18F01CC-276D-27B6-3B25-3ABD191B7E2E}"/>
                  </a:ext>
                </a:extLst>
              </p:cNvPr>
              <p:cNvGrpSpPr/>
              <p:nvPr/>
            </p:nvGrpSpPr>
            <p:grpSpPr>
              <a:xfrm>
                <a:off x="3557836" y="4291115"/>
                <a:ext cx="1341168" cy="1254042"/>
                <a:chOff x="8001775" y="1698750"/>
                <a:chExt cx="1779092" cy="1810483"/>
              </a:xfrm>
            </p:grpSpPr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xmlns="" id="{91A03F7B-3ED5-0F2D-FF27-9EE03B124AC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660927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xmlns="" id="{8DD80F1A-3367-1A99-D4DC-65CEA650B4B4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94356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xmlns="" id="{828805D8-CB2C-0DD8-560A-BEB67139F1B6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51518" y="2637382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xmlns="" id="{2E018353-D211-471A-5E9C-662BB751F8C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8" name="直線コネクタ 27">
                  <a:extLst>
                    <a:ext uri="{FF2B5EF4-FFF2-40B4-BE49-F238E27FC236}">
                      <a16:creationId xmlns:a16="http://schemas.microsoft.com/office/drawing/2014/main" xmlns="" id="{4A5FC116-D230-3EE9-A17A-F61DDF3B7B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13937" y="1980130"/>
                  <a:ext cx="176693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xmlns="" id="{D53F44BC-B2A3-6AF9-8B82-17C8A11F6637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xmlns="" id="{EA51B021-07FA-6791-0D58-D6D157D32D2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79959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xmlns="" id="{C6EB74B4-EEBA-A3F2-978F-E2F31FBD595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21838" y="4577757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直線コネクタ 20">
                <a:extLst>
                  <a:ext uri="{FF2B5EF4-FFF2-40B4-BE49-F238E27FC236}">
                    <a16:creationId xmlns:a16="http://schemas.microsoft.com/office/drawing/2014/main" xmlns="" id="{BB798F9C-E366-2324-CAF6-FB949D83B41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xmlns="" id="{0466ED86-E35B-3D98-1347-66B8E514721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6703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xmlns="" id="{D8DECDAA-CDD9-ED49-5AB1-36B64290AC1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2311" y="4583899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xmlns="" id="{FCCBEE48-AEAC-BE10-0411-0E2C60C04AF7}"/>
                </a:ext>
              </a:extLst>
            </p:cNvPr>
            <p:cNvGrpSpPr/>
            <p:nvPr/>
          </p:nvGrpSpPr>
          <p:grpSpPr>
            <a:xfrm>
              <a:off x="8849596" y="4856980"/>
              <a:ext cx="1341168" cy="1286373"/>
              <a:chOff x="3557836" y="4291115"/>
              <a:chExt cx="1341168" cy="1254042"/>
            </a:xfrm>
          </p:grpSpPr>
          <p:grpSp>
            <p:nvGrpSpPr>
              <p:cNvPr id="31" name="グループ化 30">
                <a:extLst>
                  <a:ext uri="{FF2B5EF4-FFF2-40B4-BE49-F238E27FC236}">
                    <a16:creationId xmlns:a16="http://schemas.microsoft.com/office/drawing/2014/main" xmlns="" id="{DA870EFC-0FFB-0D77-27F9-F9549B225A06}"/>
                  </a:ext>
                </a:extLst>
              </p:cNvPr>
              <p:cNvGrpSpPr/>
              <p:nvPr/>
            </p:nvGrpSpPr>
            <p:grpSpPr>
              <a:xfrm>
                <a:off x="3557836" y="4291115"/>
                <a:ext cx="1341168" cy="1254042"/>
                <a:chOff x="8001775" y="1698750"/>
                <a:chExt cx="1779092" cy="1810483"/>
              </a:xfrm>
            </p:grpSpPr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xmlns="" id="{30F17551-DF0F-3DEA-92FB-129D54847695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7660927" y="2615640"/>
                  <a:ext cx="1186412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01%</a:t>
                  </a:r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xmlns="" id="{EDAA883E-A6ED-00BE-1F49-F59A7C03464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094356" y="2641130"/>
                  <a:ext cx="1231491" cy="504716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.1%</a:t>
                  </a:r>
                </a:p>
                <a:p>
                  <a:pPr algn="ctr"/>
                  <a:r>
                    <a:rPr kumimoji="1" lang="ja-JP" alt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/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xmlns="" id="{C196EE1F-4D8C-1F2F-F7AC-4ADE23CDC48E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8651518" y="2637382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MRC-5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xmlns="" id="{1EE84E5C-4862-5F85-FBFC-21446E3A99F1}"/>
                    </a:ext>
                  </a:extLst>
                </p:cNvPr>
                <p:cNvSpPr txBox="1"/>
                <p:nvPr/>
              </p:nvSpPr>
              <p:spPr>
                <a:xfrm rot="16200000" flipH="1">
                  <a:off x="9057954" y="2581144"/>
                  <a:ext cx="1036948" cy="300578"/>
                </a:xfrm>
                <a:prstGeom prst="rect">
                  <a:avLst/>
                </a:prstGeom>
                <a:noFill/>
              </p:spPr>
              <p:txBody>
                <a:bodyPr wrap="square" lIns="36000" tIns="36000" rIns="36000" bIns="36000" rtlCol="0" anchor="ctr" anchorCtr="1">
                  <a:spAutoFit/>
                </a:bodyPr>
                <a:lstStyle/>
                <a:p>
                  <a:pPr algn="ctr"/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kumimoji="1"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ja-JP" sz="1000" baseline="30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eLa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xmlns="" id="{56691580-11F1-CBFB-8E7E-B3835BC712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013937" y="1980130"/>
                  <a:ext cx="1766930" cy="0"/>
                </a:xfrm>
                <a:prstGeom prst="line">
                  <a:avLst/>
                </a:prstGeom>
                <a:ln w="22225">
                  <a:solidFill>
                    <a:schemeClr val="bg1">
                      <a:alpha val="93000"/>
                    </a:schemeClr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xmlns="" id="{E39A66BD-7357-AC6C-CA07-7E6733C441F0}"/>
                    </a:ext>
                  </a:extLst>
                </p:cNvPr>
                <p:cNvSpPr txBox="1"/>
                <p:nvPr/>
              </p:nvSpPr>
              <p:spPr>
                <a:xfrm flipH="1">
                  <a:off x="8650635" y="1698750"/>
                  <a:ext cx="597053" cy="2165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1">
                  <a:spAutoFit/>
                </a:bodyPr>
                <a:lstStyle/>
                <a:p>
                  <a:pPr algn="ctr"/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kumimoji="1"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altLang="ja-JP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eek</a:t>
                  </a:r>
                  <a:endParaRPr kumimoji="1" lang="ja-JP" alt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xmlns="" id="{360BD426-6745-E4D2-BE8B-7FC8A423BA4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479959" y="4580544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xmlns="" id="{D3C7D5F4-4540-10CE-3ADE-A8B9B2A15AB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821838" y="4577757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>
                <a:extLst>
                  <a:ext uri="{FF2B5EF4-FFF2-40B4-BE49-F238E27FC236}">
                    <a16:creationId xmlns:a16="http://schemas.microsoft.com/office/drawing/2014/main" xmlns="" id="{DE319A40-EA40-3E76-810C-662EC38052A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126862" y="4586695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xmlns="" id="{CE462B6A-8FF0-F982-8B09-E14DE6310A6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467037" y="4586696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xmlns="" id="{1DFB82A6-63E5-EEAB-B9B1-AC3C2686CCD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2311" y="4583899"/>
                <a:ext cx="180000" cy="0"/>
              </a:xfrm>
              <a:prstGeom prst="line">
                <a:avLst/>
              </a:prstGeom>
              <a:ln w="22225">
                <a:solidFill>
                  <a:schemeClr val="bg1">
                    <a:alpha val="93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110048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2</TotalTime>
  <Words>314</Words>
  <Application>Microsoft Office PowerPoint</Application>
  <PresentationFormat>ワイド画面</PresentationFormat>
  <Paragraphs>124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dai-nakamura</dc:creator>
  <cp:lastModifiedBy>d_nakamura</cp:lastModifiedBy>
  <cp:revision>8</cp:revision>
  <dcterms:created xsi:type="dcterms:W3CDTF">2023-03-11T08:09:56Z</dcterms:created>
  <dcterms:modified xsi:type="dcterms:W3CDTF">2023-03-16T04:14:34Z</dcterms:modified>
</cp:coreProperties>
</file>